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74BD56-2A5D-4FCE-8831-25B098E664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A7857-62BA-4842-96E6-C80DD3FD40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70A56-6778-4F7C-B372-803836FB9D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974DA4-C5CF-4C03-AD5D-C6EC1A67B7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7DB765-AA9C-4F35-8F37-165EEB4445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9EF4E2-1951-4641-9350-58C68B5152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A97EAF-8D93-46B7-BAD5-9DA4D78E20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5A00C-BBEC-4CEB-B339-86AA01D53B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3A7F0D-9E76-494E-AB28-70D5EF1F1D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5DEA2-D978-4783-8718-E11A4DC8B3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DE0B6-3693-4856-815F-13E229077F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556CB-4A81-4186-BFD2-DC458B0F89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F62329-28F7-40C9-9E77-2F9ACF6BA346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1"/>
          <p:cNvSpPr/>
          <p:nvPr/>
        </p:nvSpPr>
        <p:spPr>
          <a:xfrm>
            <a:off x="457200" y="5410080"/>
            <a:ext cx="6248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Chromosome numbers show that STB03 (2n=4x=36) is tetraploid (A) and BTS02 (2n=6x=54) is hexaploid (B). The numbers were determined by the conventional acetocarmine metho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3" descr="M:\F\B_ZhejiangUniversity\稗草叶绿体\修改2\新建文件夹\稗草染色体结果_2014\稗草染色体结果_2014\未标题-2.tif"/>
          <p:cNvPicPr/>
          <p:nvPr/>
        </p:nvPicPr>
        <p:blipFill>
          <a:blip r:embed="rId1"/>
          <a:stretch/>
        </p:blipFill>
        <p:spPr>
          <a:xfrm>
            <a:off x="969840" y="2057400"/>
            <a:ext cx="2254320" cy="21337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M:\F\B_ZhejiangUniversity\稗草叶绿体\修改2\新建文件夹\稗草染色体结果_2014\稗草染色体结果_2014\未标题-1.tif"/>
          <p:cNvPicPr/>
          <p:nvPr/>
        </p:nvPicPr>
        <p:blipFill>
          <a:blip r:embed="rId2"/>
          <a:stretch/>
        </p:blipFill>
        <p:spPr>
          <a:xfrm>
            <a:off x="3179880" y="2057400"/>
            <a:ext cx="2230200" cy="2133720"/>
          </a:xfrm>
          <a:prstGeom prst="rect">
            <a:avLst/>
          </a:prstGeom>
          <a:ln w="0">
            <a:noFill/>
          </a:ln>
        </p:spPr>
      </p:pic>
      <p:sp>
        <p:nvSpPr>
          <p:cNvPr id="44" name="TextBox 15"/>
          <p:cNvSpPr/>
          <p:nvPr/>
        </p:nvSpPr>
        <p:spPr>
          <a:xfrm>
            <a:off x="1038600" y="20574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6"/>
          <p:cNvSpPr/>
          <p:nvPr/>
        </p:nvSpPr>
        <p:spPr>
          <a:xfrm>
            <a:off x="3248280" y="20574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04:17:23Z</dcterms:created>
  <dc:creator>Chuyu YE</dc:creator>
  <dc:description/>
  <dc:language>en-US</dc:language>
  <cp:lastModifiedBy>user</cp:lastModifiedBy>
  <dcterms:modified xsi:type="dcterms:W3CDTF">2014-11-01T04:18:12Z</dcterms:modified>
  <cp:revision>2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